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9" r:id="rId3"/>
    <p:sldId id="260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ngelbeen, S. (HG)" initials="ES(" lastIdx="2" clrIdx="0">
    <p:extLst>
      <p:ext uri="{19B8F6BF-5375-455C-9EA6-DF929625EA0E}">
        <p15:presenceInfo xmlns:p15="http://schemas.microsoft.com/office/powerpoint/2012/main" userId="S::S.Engelbeen@lumc.nl::7c15f733-7262-41ae-9b46-a9a6089c4a29" providerId="AD"/>
      </p:ext>
    </p:extLst>
  </p:cmAuthor>
  <p:cmAuthor id="2" name="Putten, M. van (HG)" initials="PMv(" lastIdx="3" clrIdx="1">
    <p:extLst>
      <p:ext uri="{19B8F6BF-5375-455C-9EA6-DF929625EA0E}">
        <p15:presenceInfo xmlns:p15="http://schemas.microsoft.com/office/powerpoint/2012/main" userId="S::M.van_Putten@lumc.nl::bd2710cb-67aa-4a72-b080-3dab833e107f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4660"/>
  </p:normalViewPr>
  <p:slideViewPr>
    <p:cSldViewPr snapToGrid="0">
      <p:cViewPr varScale="1">
        <p:scale>
          <a:sx n="91" d="100"/>
          <a:sy n="91" d="100"/>
        </p:scale>
        <p:origin x="275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6100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38153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56950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15955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53156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05936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22235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39127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61765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65210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95672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CE366-5D7A-4939-9310-E824B8C8590C}" type="datetimeFigureOut">
              <a:rPr lang="nl-NL" smtClean="0"/>
              <a:t>04-07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1FB708-964E-4DB5-80FE-C08487F3288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3249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120072D-2111-443A-9A00-F649A72E05E9}"/>
              </a:ext>
            </a:extLst>
          </p:cNvPr>
          <p:cNvSpPr/>
          <p:nvPr/>
        </p:nvSpPr>
        <p:spPr>
          <a:xfrm>
            <a:off x="2133981" y="7249149"/>
            <a:ext cx="666369" cy="536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D9F19E8-9FA8-486F-9CD3-5155A93D3574}"/>
              </a:ext>
            </a:extLst>
          </p:cNvPr>
          <p:cNvSpPr txBox="1"/>
          <p:nvPr/>
        </p:nvSpPr>
        <p:spPr>
          <a:xfrm>
            <a:off x="289508" y="684643"/>
            <a:ext cx="38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nl-NL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977AA9D-0F35-4BF0-AF00-769B002D3330}"/>
              </a:ext>
            </a:extLst>
          </p:cNvPr>
          <p:cNvSpPr txBox="1"/>
          <p:nvPr/>
        </p:nvSpPr>
        <p:spPr>
          <a:xfrm>
            <a:off x="289508" y="3490565"/>
            <a:ext cx="38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nl-NL" b="1" dirty="0"/>
          </a:p>
        </p:txBody>
      </p:sp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C1543C13-FDEB-470A-8CEE-9FB994D4A6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496" y="733845"/>
            <a:ext cx="6516624" cy="2740152"/>
          </a:xfrm>
          <a:prstGeom prst="rect">
            <a:avLst/>
          </a:prstGeom>
        </p:spPr>
      </p:pic>
      <p:pic>
        <p:nvPicPr>
          <p:cNvPr id="6" name="Picture 5" descr="Chart, bar chart&#10;&#10;Description automatically generated">
            <a:extLst>
              <a:ext uri="{FF2B5EF4-FFF2-40B4-BE49-F238E27FC236}">
                <a16:creationId xmlns:a16="http://schemas.microsoft.com/office/drawing/2014/main" id="{D5AB42B0-7EC4-4181-8C04-328E632C0EB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" y="3550659"/>
            <a:ext cx="6507480" cy="2712720"/>
          </a:xfrm>
          <a:prstGeom prst="rect">
            <a:avLst/>
          </a:prstGeom>
        </p:spPr>
      </p:pic>
      <p:pic>
        <p:nvPicPr>
          <p:cNvPr id="7" name="Picture 6" descr="Chart, bar chart&#10;&#10;Description automatically generated">
            <a:extLst>
              <a:ext uri="{FF2B5EF4-FFF2-40B4-BE49-F238E27FC236}">
                <a16:creationId xmlns:a16="http://schemas.microsoft.com/office/drawing/2014/main" id="{BA9274B0-50A1-4FA7-BD8E-C291E70CA80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528" r="34331" b="79599"/>
          <a:stretch/>
        </p:blipFill>
        <p:spPr>
          <a:xfrm>
            <a:off x="4928511" y="3428090"/>
            <a:ext cx="1377696" cy="97688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AFF9B16-16BC-4EFE-AF20-8858F793C606}"/>
              </a:ext>
            </a:extLst>
          </p:cNvPr>
          <p:cNvSpPr txBox="1"/>
          <p:nvPr/>
        </p:nvSpPr>
        <p:spPr>
          <a:xfrm>
            <a:off x="441908" y="837043"/>
            <a:ext cx="38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nl-NL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04B2AED-2B4F-41B3-B1C8-0611434CFAC7}"/>
              </a:ext>
            </a:extLst>
          </p:cNvPr>
          <p:cNvSpPr txBox="1"/>
          <p:nvPr/>
        </p:nvSpPr>
        <p:spPr>
          <a:xfrm>
            <a:off x="441908" y="3642965"/>
            <a:ext cx="38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nl-NL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236BA1E-D486-4F17-984D-1070B2772B33}"/>
              </a:ext>
            </a:extLst>
          </p:cNvPr>
          <p:cNvSpPr txBox="1"/>
          <p:nvPr/>
        </p:nvSpPr>
        <p:spPr>
          <a:xfrm>
            <a:off x="289508" y="6568225"/>
            <a:ext cx="6016699" cy="2625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Supplementary Figure 1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Systemic treatment of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Alk4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 siRNAs in wildtype mice (n=3 per group). (A) Wildtype mice were treated with a single IV injection of 10 mg/kg siRNA.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Alk4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 transcript levels were assessed by qPCR in the tibialis anterior (TA), gastrocnemius (Gas), diaphragm (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Di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), heart (Ha) and liver (Li). (B)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Alk4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transcript levels after a single IP injection of 10 mg/kg siRNA. A two-way ANOVA was performed to compare between route of administration and the different siRNAs, followed by the Bonferroni’s multiple comparisons to compare between different groups. *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P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&lt;0.05.</a:t>
            </a:r>
            <a:endParaRPr lang="nl-NL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6946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bar chart&#10;&#10;Description automatically generated">
            <a:extLst>
              <a:ext uri="{FF2B5EF4-FFF2-40B4-BE49-F238E27FC236}">
                <a16:creationId xmlns:a16="http://schemas.microsoft.com/office/drawing/2014/main" id="{C049F5E7-D5AA-44E7-A9AC-E206328B603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5581"/>
          <a:stretch/>
        </p:blipFill>
        <p:spPr>
          <a:xfrm>
            <a:off x="303276" y="255413"/>
            <a:ext cx="4715256" cy="2674334"/>
          </a:xfrm>
        </p:spPr>
      </p:pic>
      <p:pic>
        <p:nvPicPr>
          <p:cNvPr id="7" name="Picture 6" descr="Chart, bar chart&#10;&#10;Description automatically generated">
            <a:extLst>
              <a:ext uri="{FF2B5EF4-FFF2-40B4-BE49-F238E27FC236}">
                <a16:creationId xmlns:a16="http://schemas.microsoft.com/office/drawing/2014/main" id="{524C9070-7741-44A0-BC81-105992D38A5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10" t="79432" r="16451"/>
          <a:stretch/>
        </p:blipFill>
        <p:spPr>
          <a:xfrm>
            <a:off x="4506468" y="853440"/>
            <a:ext cx="2048256" cy="73914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1A8E750-2EFA-42A0-8E80-D7029DA67FAC}"/>
              </a:ext>
            </a:extLst>
          </p:cNvPr>
          <p:cNvSpPr txBox="1"/>
          <p:nvPr/>
        </p:nvSpPr>
        <p:spPr>
          <a:xfrm>
            <a:off x="289508" y="3141863"/>
            <a:ext cx="6016699" cy="1887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Supplementary Figure 2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Alk4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downregulation after longitudinal treatment with 10 mg/kg siRNA in wildtype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mice (n=6 per group) resulted in significant downregulation in the tibialis anterior (TA), gastrocnemius (Gas), diaphragm (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Di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), heart (Ha) and liver (Li). A Welch’s t-test was used to analyze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Alk4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 levels between treatment groups for each tissue type. *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P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&lt;0.05, **P&lt;0.01, ****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P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&lt;0.0001.</a:t>
            </a:r>
            <a:endParaRPr lang="nl-NL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21212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bar chart&#10;&#10;Description automatically generated">
            <a:extLst>
              <a:ext uri="{FF2B5EF4-FFF2-40B4-BE49-F238E27FC236}">
                <a16:creationId xmlns:a16="http://schemas.microsoft.com/office/drawing/2014/main" id="{60BC907D-EE50-4AE2-B7C1-E887B40F95B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" y="737540"/>
            <a:ext cx="2837688" cy="2474976"/>
          </a:xfrm>
        </p:spPr>
      </p:pic>
      <p:pic>
        <p:nvPicPr>
          <p:cNvPr id="7" name="Picture 6" descr="Chart, bar chart&#10;&#10;Description automatically generated">
            <a:extLst>
              <a:ext uri="{FF2B5EF4-FFF2-40B4-BE49-F238E27FC236}">
                <a16:creationId xmlns:a16="http://schemas.microsoft.com/office/drawing/2014/main" id="{77D039F5-B88C-44C4-8351-1463F642E5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780" y="745601"/>
            <a:ext cx="2764536" cy="2474976"/>
          </a:xfrm>
          <a:prstGeom prst="rect">
            <a:avLst/>
          </a:prstGeom>
        </p:spPr>
      </p:pic>
      <p:pic>
        <p:nvPicPr>
          <p:cNvPr id="9" name="Picture 8" descr="Chart, box and whisker chart&#10;&#10;Description automatically generated">
            <a:extLst>
              <a:ext uri="{FF2B5EF4-FFF2-40B4-BE49-F238E27FC236}">
                <a16:creationId xmlns:a16="http://schemas.microsoft.com/office/drawing/2014/main" id="{12B6D128-18F3-47F5-AB0B-307D3513C09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872" y="3397709"/>
            <a:ext cx="2764536" cy="2474976"/>
          </a:xfrm>
          <a:prstGeom prst="rect">
            <a:avLst/>
          </a:prstGeom>
        </p:spPr>
      </p:pic>
      <p:pic>
        <p:nvPicPr>
          <p:cNvPr id="11" name="Picture 10" descr="Chart, bar chart&#10;&#10;Description automatically generated">
            <a:extLst>
              <a:ext uri="{FF2B5EF4-FFF2-40B4-BE49-F238E27FC236}">
                <a16:creationId xmlns:a16="http://schemas.microsoft.com/office/drawing/2014/main" id="{5F832FA4-FB1C-4E02-9C99-51407ECDB91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548"/>
          <a:stretch/>
        </p:blipFill>
        <p:spPr>
          <a:xfrm>
            <a:off x="3584448" y="3397709"/>
            <a:ext cx="2595372" cy="2474976"/>
          </a:xfrm>
          <a:prstGeom prst="rect">
            <a:avLst/>
          </a:prstGeom>
        </p:spPr>
      </p:pic>
      <p:pic>
        <p:nvPicPr>
          <p:cNvPr id="12" name="Picture 11" descr="Chart, bar chart&#10;&#10;Description automatically generated">
            <a:extLst>
              <a:ext uri="{FF2B5EF4-FFF2-40B4-BE49-F238E27FC236}">
                <a16:creationId xmlns:a16="http://schemas.microsoft.com/office/drawing/2014/main" id="{C7C0709E-B459-4EF8-85C3-18AF8A68C79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093" t="16975" r="-1255" b="52090"/>
          <a:stretch/>
        </p:blipFill>
        <p:spPr>
          <a:xfrm>
            <a:off x="2501646" y="5963647"/>
            <a:ext cx="2144268" cy="76563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7B8C2F2D-0055-4D83-AE6A-B9AACCE0D2A8}"/>
              </a:ext>
            </a:extLst>
          </p:cNvPr>
          <p:cNvSpPr txBox="1"/>
          <p:nvPr/>
        </p:nvSpPr>
        <p:spPr>
          <a:xfrm>
            <a:off x="449399" y="909499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/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5B33F53-2628-463C-AD12-06E73B6D3434}"/>
              </a:ext>
            </a:extLst>
          </p:cNvPr>
          <p:cNvSpPr txBox="1"/>
          <p:nvPr/>
        </p:nvSpPr>
        <p:spPr>
          <a:xfrm>
            <a:off x="3453720" y="904665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/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5054E74-B093-434A-A9D3-B2AC9E7DECE0}"/>
              </a:ext>
            </a:extLst>
          </p:cNvPr>
          <p:cNvSpPr txBox="1"/>
          <p:nvPr/>
        </p:nvSpPr>
        <p:spPr>
          <a:xfrm>
            <a:off x="449399" y="3553832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/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8057941-5EED-4D5C-B27E-556D53072979}"/>
              </a:ext>
            </a:extLst>
          </p:cNvPr>
          <p:cNvSpPr txBox="1"/>
          <p:nvPr/>
        </p:nvSpPr>
        <p:spPr>
          <a:xfrm>
            <a:off x="3444242" y="3548436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/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4122881-A70A-4F48-92A0-D0EB25A4DA5C}"/>
              </a:ext>
            </a:extLst>
          </p:cNvPr>
          <p:cNvSpPr txBox="1"/>
          <p:nvPr/>
        </p:nvSpPr>
        <p:spPr>
          <a:xfrm>
            <a:off x="289508" y="6662817"/>
            <a:ext cx="6016699" cy="15179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Supplementary Figure 3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The tolerability of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Alk4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-targeting siRNA treatment was assessed by quantification of markers for kidney and liver function in wildtype mice (n=6 per group).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ALP: alkaline phosphatase, GOT: glutamic oxaloacetic transaminase, GPT: glutamic-pyruvic transaminase. A Welch’s t-test was performed to compare treatment groups. </a:t>
            </a:r>
            <a:endParaRPr lang="nl-NL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3226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768</TotalTime>
  <Words>267</Words>
  <Application>Microsoft Office PowerPoint</Application>
  <PresentationFormat>A4 Paper (210x297 mm)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ngelbeen, S. (HG)</dc:creator>
  <cp:lastModifiedBy>Engelbeen, S. (HG)</cp:lastModifiedBy>
  <cp:revision>53</cp:revision>
  <dcterms:created xsi:type="dcterms:W3CDTF">2020-04-17T07:25:54Z</dcterms:created>
  <dcterms:modified xsi:type="dcterms:W3CDTF">2022-07-04T11:29:45Z</dcterms:modified>
</cp:coreProperties>
</file>